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56" r:id="rId3"/>
    <p:sldId id="257" r:id="rId4"/>
    <p:sldId id="264" r:id="rId5"/>
    <p:sldId id="265" r:id="rId6"/>
    <p:sldId id="259" r:id="rId7"/>
    <p:sldId id="260" r:id="rId8"/>
    <p:sldId id="261" r:id="rId9"/>
    <p:sldId id="272" r:id="rId10"/>
    <p:sldId id="270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DEDEFA-E724-4037-83C7-C0AE60C67E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01628E4-2811-4000-93E7-22E4DDABBD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CA1A30-F17A-47D3-9B7F-DC28BF580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1A8E72-BCAA-46EC-88F7-82BAD6AE6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106FCC8-C112-4ED4-912A-8CDD65683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11475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344D38-A23E-474A-B47E-F554235C51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3CAEF31-ED08-4E97-BEE0-7F310206BC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9ED5949-0D19-4168-B9B1-2C4AD918A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45D69D-3408-434A-BE1D-400CE214A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D630CA-971D-448D-96EC-278687C2D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5598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36E4D8E-E3F5-4355-A1CA-77E1246A90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DD1C4AA-6451-4723-AAC7-16FE2A356F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33F180-F125-474D-AB42-D4E642BE2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6F1465-4F26-452A-9811-ABF482F3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5C8DE7-DED6-421D-A957-577C8C4EF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0077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B6BA03-9910-433C-929D-8A92A3B06B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C4C876-B31D-4053-9CB5-FD723E8FA6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03BA64-BF5F-4647-94C9-BB95EBCD1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E933D2-3BF6-42C7-9B35-329DFF631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223D6D-9B0A-4BB4-B4F2-942DAD07C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4408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79B10E-2E16-453C-BB5C-2ECEEAD5DB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32B240A-26C1-437E-8CE6-6DC1FB70F7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B495E0-9B6E-4B8F-AE9A-F1FFBCBB6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1B0AF0-E5E0-4C5B-898B-669942A6EA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19BE1B-E0E6-46F6-81FB-BFFA002A1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2696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253A86-A595-4362-9D44-6DE097CBCF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92A3272-C1E7-458F-AFD1-BFFE72F27A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63391FB-4A75-47D8-BD90-A97AC11D2A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33668CA-4789-498D-803C-A5DF1C6470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AE7D12D-2D6B-4470-9D06-86F8266F92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5085432-36C0-407C-BF4A-B5FAE69F2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6434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AD453A-8F7D-4540-A24A-4A3AACD0CD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19DC93C-23B5-46F4-B332-4538326C39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E78CDAF-BD1F-4CAC-91AD-ECB3CC6D76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776D424-5ED0-4DF9-AA49-C24242C040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5C8FF63-D611-4797-9E70-7BDED6B782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DD7A1F9-E4F3-4546-B3D0-0A0A987F4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AE380A1-C35B-4549-B437-21AA327E7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BFE95F7-7922-4DA6-8472-06458D43B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364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095D26-AE3A-4369-BE6A-894ECBEA63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5B904B6-AA40-431C-B6EE-35A453171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2FE5694-9042-4046-A4BB-2269B9A88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6A98C9F-DE5D-4157-8E43-E8F4BAFE9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0272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B2274BF-4C9E-4A13-9537-122D13078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0AD19FF-DCF7-4497-A1EC-9FEC585FC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035433E-98DA-4E0A-89F5-EC8FD906D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242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CA82BA-833C-4C89-AAAC-3ADF5339F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6452E65-EE0B-46C0-AAD4-2759C7463D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FD6DC4C-125B-4CAD-9FFD-3B6050DD79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68EB1FE-310C-4C5F-B777-153BF3867F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7C809E-1B0C-4F29-A9A9-C79177541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EDC1458-EE27-4AD3-BBD1-7AE9117C7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4503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7F2146-8AE0-410B-96B8-0BFA94E9CC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C2294A3-27CF-44F1-9383-33C7E78A1E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380AB36-4A57-4FE4-8B50-DF286496B0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D61F52C-89B0-40A6-A292-B1D136B2C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8F02C13-E83A-4E0F-B57A-754C59F72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04D54F5-78D1-4902-AC56-E291C3D63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9836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1215394-7722-492F-B98E-6CD56AC857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E7D2273-3BDE-4B68-B6F4-87E0AEC9E7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B0B580-C24D-433E-A66A-BFCD5936A4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29D26-33A2-46CB-BFCE-451F1588D74B}" type="datetimeFigureOut">
              <a:rPr lang="zh-CN" altLang="en-US" smtClean="0"/>
              <a:t>2019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2DBB4E-9EF6-4A18-AB21-43DC9C417D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0FA71F-3F2A-4068-BD45-49879121C5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BAC046-CDC8-4ED6-8295-06D817813D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266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cqiang8@189.cn" TargetMode="External"/><Relationship Id="rId2" Type="http://schemas.openxmlformats.org/officeDocument/2006/relationships/hyperlink" Target="mailto:zhangxq@genomics.cn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632F9E1-2EB4-4100-868E-6AC48415DD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06315"/>
            <a:ext cx="10515600" cy="4351338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altLang="zh-CN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buNone/>
            </a:pPr>
            <a:r>
              <a:rPr lang="en-US" altLang="zh-CN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Profiles and </a:t>
            </a:r>
            <a:r>
              <a:rPr lang="en-US" altLang="zh-CN" sz="4000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stasis Markers </a:t>
            </a:r>
            <a:r>
              <a:rPr lang="en-US" altLang="zh-CN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hinese Patients with Gastric Carcinoma</a:t>
            </a:r>
          </a:p>
          <a:p>
            <a:pPr marL="0" indent="0" algn="ctr">
              <a:buNone/>
            </a:pPr>
            <a:r>
              <a:rPr lang="en-US" altLang="zh-CN" sz="2000" b="1" dirty="0"/>
              <a:t>Chao Chen</a:t>
            </a:r>
            <a:r>
              <a:rPr lang="en-US" altLang="zh-CN" sz="2000" b="1" baseline="30000" dirty="0"/>
              <a:t>1,3,5,10</a:t>
            </a:r>
            <a:r>
              <a:rPr lang="en-US" altLang="zh-CN" sz="2000" b="1" dirty="0"/>
              <a:t>, </a:t>
            </a:r>
            <a:r>
              <a:rPr lang="en-US" altLang="zh-CN" sz="2000" b="1" dirty="0" err="1"/>
              <a:t>Chunmei</a:t>
            </a:r>
            <a:r>
              <a:rPr lang="en-US" altLang="zh-CN" sz="2000" b="1" dirty="0"/>
              <a:t> Shi</a:t>
            </a:r>
            <a:r>
              <a:rPr lang="en-US" altLang="zh-CN" sz="2000" b="1" baseline="30000" dirty="0"/>
              <a:t>2,6,10</a:t>
            </a:r>
            <a:r>
              <a:rPr lang="en-US" altLang="zh-CN" sz="2000" b="1" dirty="0"/>
              <a:t>, Xiaochun Huang</a:t>
            </a:r>
            <a:r>
              <a:rPr lang="en-US" altLang="zh-CN" sz="2000" b="1" baseline="30000" dirty="0"/>
              <a:t>3,5,10</a:t>
            </a:r>
            <a:r>
              <a:rPr lang="en-US" altLang="zh-CN" sz="2000" b="1" dirty="0"/>
              <a:t>, </a:t>
            </a:r>
            <a:r>
              <a:rPr lang="en-US" altLang="zh-CN" sz="2000" b="1" dirty="0" err="1"/>
              <a:t>Jianwei</a:t>
            </a:r>
            <a:r>
              <a:rPr lang="en-US" altLang="zh-CN" sz="2000" b="1" dirty="0"/>
              <a:t> Zheng</a:t>
            </a:r>
            <a:r>
              <a:rPr lang="en-US" altLang="zh-CN" sz="2000" b="1" baseline="30000" dirty="0"/>
              <a:t>2,6</a:t>
            </a:r>
            <a:r>
              <a:rPr lang="en-US" altLang="zh-CN" sz="2000" b="1" dirty="0"/>
              <a:t>, Zhongyi Zhu</a:t>
            </a:r>
            <a:r>
              <a:rPr lang="en-US" altLang="zh-CN" sz="2000" b="1" baseline="30000" dirty="0"/>
              <a:t>3,5</a:t>
            </a:r>
            <a:r>
              <a:rPr lang="en-US" altLang="zh-CN" sz="2000" b="1" dirty="0"/>
              <a:t>, </a:t>
            </a:r>
            <a:r>
              <a:rPr lang="en-US" altLang="zh-CN" sz="2000" b="1" dirty="0" err="1"/>
              <a:t>Qiaolian</a:t>
            </a:r>
            <a:r>
              <a:rPr lang="en-US" altLang="zh-CN" sz="2000" b="1" dirty="0"/>
              <a:t> Li</a:t>
            </a:r>
            <a:r>
              <a:rPr lang="en-US" altLang="zh-CN" sz="2000" b="1" baseline="30000" dirty="0"/>
              <a:t>4,6,7</a:t>
            </a:r>
            <a:r>
              <a:rPr lang="en-US" altLang="zh-CN" sz="2000" b="1" dirty="0"/>
              <a:t>, Si Qiu</a:t>
            </a:r>
            <a:r>
              <a:rPr lang="en-US" altLang="zh-CN" sz="2000" b="1" baseline="30000" dirty="0"/>
              <a:t>1,3,5</a:t>
            </a:r>
            <a:r>
              <a:rPr lang="en-US" altLang="zh-CN" sz="2000" b="1" dirty="0"/>
              <a:t>, </a:t>
            </a:r>
            <a:r>
              <a:rPr lang="en-US" altLang="zh-CN" sz="2000" b="1" dirty="0" err="1"/>
              <a:t>Zhiqing</a:t>
            </a:r>
            <a:r>
              <a:rPr lang="en-US" altLang="zh-CN" sz="2000" b="1" dirty="0"/>
              <a:t> Huang</a:t>
            </a:r>
            <a:r>
              <a:rPr lang="en-US" altLang="zh-CN" sz="2000" b="1" baseline="30000" dirty="0"/>
              <a:t>4,7</a:t>
            </a:r>
            <a:r>
              <a:rPr lang="en-US" altLang="zh-CN" sz="2000" b="1" dirty="0"/>
              <a:t>, Zhenkun Zhuang</a:t>
            </a:r>
            <a:r>
              <a:rPr lang="en-US" altLang="zh-CN" sz="2000" b="1" baseline="30000" dirty="0"/>
              <a:t>3,5,8</a:t>
            </a:r>
            <a:r>
              <a:rPr lang="en-US" altLang="zh-CN" sz="2000" b="1" dirty="0"/>
              <a:t>, </a:t>
            </a:r>
            <a:r>
              <a:rPr lang="en-US" altLang="zh-CN" sz="2000" b="1" dirty="0" err="1"/>
              <a:t>Riping</a:t>
            </a:r>
            <a:r>
              <a:rPr lang="en-US" altLang="zh-CN" sz="2000" b="1" dirty="0"/>
              <a:t> Wu</a:t>
            </a:r>
            <a:r>
              <a:rPr lang="en-US" altLang="zh-CN" sz="2000" b="1" baseline="30000" dirty="0"/>
              <a:t>2,4</a:t>
            </a:r>
            <a:r>
              <a:rPr lang="en-US" altLang="zh-CN" sz="2000" b="1" dirty="0"/>
              <a:t>, Panhong Liu</a:t>
            </a:r>
            <a:r>
              <a:rPr lang="en-US" altLang="zh-CN" sz="2000" b="1" baseline="30000" dirty="0"/>
              <a:t>3,5</a:t>
            </a:r>
            <a:r>
              <a:rPr lang="en-US" altLang="zh-CN" sz="2000" b="1" dirty="0"/>
              <a:t>, Fan Wu</a:t>
            </a:r>
            <a:r>
              <a:rPr lang="en-US" altLang="zh-CN" sz="2000" b="1" baseline="30000" dirty="0"/>
              <a:t>4</a:t>
            </a:r>
            <a:r>
              <a:rPr lang="en-US" altLang="zh-CN" sz="2000" b="1" dirty="0"/>
              <a:t>, </a:t>
            </a:r>
            <a:r>
              <a:rPr lang="en-US" altLang="zh-CN" sz="2000" b="1" dirty="0" err="1"/>
              <a:t>Shanyun</a:t>
            </a:r>
            <a:r>
              <a:rPr lang="en-US" altLang="zh-CN" sz="2000" b="1" dirty="0"/>
              <a:t> Lin</a:t>
            </a:r>
            <a:r>
              <a:rPr lang="en-US" altLang="zh-CN" sz="2000" b="1" baseline="30000" dirty="0"/>
              <a:t>3,5</a:t>
            </a:r>
            <a:r>
              <a:rPr lang="en-US" altLang="zh-CN" sz="2000" b="1" dirty="0"/>
              <a:t>, Bo Li</a:t>
            </a:r>
            <a:r>
              <a:rPr lang="en-US" altLang="zh-CN" sz="2000" b="1" baseline="30000" dirty="0"/>
              <a:t>3,5,9</a:t>
            </a:r>
            <a:r>
              <a:rPr lang="en-US" altLang="zh-CN" sz="2000" b="1" dirty="0"/>
              <a:t>, Xiuqing Zhang</a:t>
            </a:r>
            <a:r>
              <a:rPr lang="en-US" altLang="zh-CN" sz="2000" b="1" baseline="30000" dirty="0"/>
              <a:t>1,3,5, * </a:t>
            </a:r>
            <a:r>
              <a:rPr lang="en-US" altLang="zh-CN" sz="2000" b="1" dirty="0"/>
              <a:t>&amp; </a:t>
            </a:r>
            <a:r>
              <a:rPr lang="en-US" altLang="zh-CN" sz="2000" b="1" dirty="0" err="1"/>
              <a:t>Qiang</a:t>
            </a:r>
            <a:r>
              <a:rPr lang="en-US" altLang="zh-CN" sz="2000" b="1" dirty="0"/>
              <a:t> Chen</a:t>
            </a:r>
            <a:r>
              <a:rPr lang="en-US" altLang="zh-CN" sz="2000" b="1" baseline="30000" dirty="0"/>
              <a:t>2,6,7, *</a:t>
            </a:r>
            <a:endParaRPr lang="zh-CN" altLang="zh-CN" sz="2000" b="1" baseline="30000" dirty="0"/>
          </a:p>
          <a:p>
            <a:pPr marL="0" indent="0" algn="ctr">
              <a:buNone/>
            </a:pPr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b="1" dirty="0"/>
              <a:t>Supplementary Figures</a:t>
            </a:r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3600" dirty="0"/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87C614ED-A1C5-44BF-A5C6-333507B2B8F6}"/>
              </a:ext>
            </a:extLst>
          </p:cNvPr>
          <p:cNvSpPr/>
          <p:nvPr/>
        </p:nvSpPr>
        <p:spPr>
          <a:xfrm>
            <a:off x="950742" y="4951247"/>
            <a:ext cx="1051560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GI Education Center, University of Chinese Academy of Sciences, Shenzhen 518083, China.</a:t>
            </a:r>
            <a:r>
              <a:rPr lang="en-US" altLang="zh-CN" sz="1400" kern="0" dirty="0">
                <a:solidFill>
                  <a:srgbClr val="1A17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zh-CN" sz="1400" kern="0" dirty="0">
                <a:solidFill>
                  <a:srgbClr val="1A17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ian Medical University Union Hospital, Fuzhou 350000, China.</a:t>
            </a:r>
            <a:r>
              <a:rPr lang="en-US" altLang="zh-CN" sz="1400" kern="0" dirty="0">
                <a:solidFill>
                  <a:srgbClr val="1A1718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GI-Shenzhen, Shenzhen 518083, China.</a:t>
            </a:r>
            <a:r>
              <a:rPr lang="en-US" altLang="zh-CN" sz="1400" kern="0" dirty="0">
                <a:solidFill>
                  <a:srgbClr val="1A17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Union Clinical Medical College of Fujian Medical University, Fuzhou 350000, China.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5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na National </a:t>
            </a:r>
            <a:r>
              <a:rPr lang="en-US" altLang="zh-CN" sz="1400" kern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Bank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BGI-Shenzhen, Shenzhen 518120, China.</a:t>
            </a:r>
            <a:r>
              <a:rPr lang="en-US" altLang="zh-CN" sz="1400" kern="0" dirty="0">
                <a:solidFill>
                  <a:srgbClr val="1A17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jian Provincial Key Laboratory of Translational Cancer Medicine, Fuzhou 350000, China. 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jian Medical University Stem Cell Research Institute, Fuzhou 350000, China.</a:t>
            </a:r>
            <a:r>
              <a:rPr lang="en-US" altLang="zh-CN" sz="1400" kern="0" dirty="0">
                <a:solidFill>
                  <a:srgbClr val="1A17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altLang="zh-CN" sz="1400" b="1" kern="0" dirty="0">
                <a:solidFill>
                  <a:srgbClr val="9C273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chool of Biology and Biological Engineering, South China University of Technology, Guangzhou 510006, China. ­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GI-</a:t>
            </a:r>
            <a:r>
              <a:rPr lang="en-US" altLang="zh-CN" sz="1400" kern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oImmune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400" kern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oxing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oad, East Lake New Technology Development Zone, Wuhan 430079, China. </a:t>
            </a:r>
            <a:r>
              <a:rPr lang="en-US" altLang="zh-CN" sz="14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se authors contributed equally to this work. </a:t>
            </a:r>
            <a:r>
              <a:rPr lang="zh-CN" altLang="en-US" sz="1400" kern="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rrespondence and requests for materials should be addressed to X.Z. (email: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zhangxq@genomics.cn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or Q.C. (email: 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cqiang8@189.cn</a:t>
            </a:r>
            <a:r>
              <a:rPr lang="en-US" altLang="zh-CN" sz="14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100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36868B5E-8CBB-4AB7-973D-AFD309ED019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781819" y="868654"/>
            <a:ext cx="9896460" cy="4856895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723C0B8B-CD46-471B-AB27-6FCF8956B36C}"/>
              </a:ext>
            </a:extLst>
          </p:cNvPr>
          <p:cNvSpPr/>
          <p:nvPr/>
        </p:nvSpPr>
        <p:spPr>
          <a:xfrm>
            <a:off x="1162929" y="5863103"/>
            <a:ext cx="951534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NewRomanPS-BoldMT"/>
              </a:rPr>
              <a:t>Supplementary Figure S5. </a:t>
            </a:r>
            <a:r>
              <a:rPr lang="en-US" altLang="zh-CN" b="1" dirty="0">
                <a:latin typeface="TimesNewRomanPSMT"/>
              </a:rPr>
              <a:t>The bioinformatics analysis pipeline of this study.</a:t>
            </a:r>
            <a:endParaRPr lang="zh-CN" altLang="en-US" b="1" dirty="0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02125954-33E9-46B7-92C3-9A8AE76EB13C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</a:t>
            </a:r>
            <a:r>
              <a:rPr lang="en-US" altLang="zh-CN" b="1" dirty="0"/>
              <a:t>5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7341978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>
            <a:extLst>
              <a:ext uri="{FF2B5EF4-FFF2-40B4-BE49-F238E27FC236}">
                <a16:creationId xmlns:a16="http://schemas.microsoft.com/office/drawing/2014/main" id="{3360A66A-13F5-4899-A409-30DEE4E9F3E5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1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8E963F08-D9DF-4390-9D7F-CBC5E470F3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2620" y="1512967"/>
            <a:ext cx="10396653" cy="383206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BF26891-CA90-419E-A98F-4F764F0346F0}"/>
              </a:ext>
            </a:extLst>
          </p:cNvPr>
          <p:cNvSpPr txBox="1"/>
          <p:nvPr/>
        </p:nvSpPr>
        <p:spPr>
          <a:xfrm>
            <a:off x="612727" y="1053779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999164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>
            <a:extLst>
              <a:ext uri="{FF2B5EF4-FFF2-40B4-BE49-F238E27FC236}">
                <a16:creationId xmlns:a16="http://schemas.microsoft.com/office/drawing/2014/main" id="{49E9A1C6-2A0D-47AF-91FB-4F4BE950D2E8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1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692BDBA-7F2A-4759-A34B-0F14C7FFE03E}"/>
              </a:ext>
            </a:extLst>
          </p:cNvPr>
          <p:cNvSpPr txBox="1"/>
          <p:nvPr/>
        </p:nvSpPr>
        <p:spPr>
          <a:xfrm>
            <a:off x="3346417" y="841086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38A38A46-F7CF-42B5-A3EE-E2FA427401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9970" y="1545228"/>
            <a:ext cx="3333333" cy="327619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C77BF32-6B62-4F5F-B797-4CC3D2FF8F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10967" y="1449989"/>
            <a:ext cx="3266667" cy="337142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07D3AA6A-F29B-4A5B-99CC-1D6100FCD0E9}"/>
              </a:ext>
            </a:extLst>
          </p:cNvPr>
          <p:cNvSpPr txBox="1"/>
          <p:nvPr/>
        </p:nvSpPr>
        <p:spPr>
          <a:xfrm>
            <a:off x="8438342" y="841086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C7AF84DD-0C38-43B9-BB4A-32CBCD97DFDE}"/>
              </a:ext>
            </a:extLst>
          </p:cNvPr>
          <p:cNvSpPr/>
          <p:nvPr/>
        </p:nvSpPr>
        <p:spPr>
          <a:xfrm>
            <a:off x="677593" y="4869038"/>
            <a:ext cx="1104079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NewRomanPS-BoldMT"/>
              </a:rPr>
              <a:t>Supplementary Figure S1. The mutation spectrum of GC in this study and the comparation with other studies.</a:t>
            </a:r>
          </a:p>
          <a:p>
            <a:r>
              <a:rPr lang="en-US" altLang="zh-CN" b="1" dirty="0">
                <a:latin typeface="TimesNewRomanPSMT"/>
              </a:rPr>
              <a:t>(A) </a:t>
            </a:r>
            <a:r>
              <a:rPr lang="en-US" altLang="zh-CN" dirty="0">
                <a:latin typeface="TimesNewRomanPSMT"/>
              </a:rPr>
              <a:t>Each signature is displayed according to the 96 context-dependent mutation patterns in three studies</a:t>
            </a:r>
            <a:r>
              <a:rPr lang="en-US" altLang="zh-CN" dirty="0"/>
              <a:t> </a:t>
            </a:r>
          </a:p>
          <a:p>
            <a:r>
              <a:rPr lang="en-US" altLang="zh-CN" b="1" dirty="0">
                <a:latin typeface="TimesNewRomanPS-BoldMT"/>
              </a:rPr>
              <a:t>(B) </a:t>
            </a:r>
            <a:r>
              <a:rPr lang="en-US" altLang="zh-CN" dirty="0">
                <a:latin typeface="TimesNewRomanPSMT"/>
              </a:rPr>
              <a:t>The overlap of top50 frequent mutated genes in three studies. </a:t>
            </a:r>
          </a:p>
          <a:p>
            <a:r>
              <a:rPr lang="en-US" altLang="zh-CN" b="1" dirty="0">
                <a:latin typeface="TimesNewRomanPS-BoldMT"/>
              </a:rPr>
              <a:t>(C) </a:t>
            </a:r>
            <a:r>
              <a:rPr lang="en-US" altLang="zh-CN" dirty="0">
                <a:latin typeface="TimesNewRomanPSMT"/>
              </a:rPr>
              <a:t>The overlap of top50 frequent mutated cancer-related genes in three studie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906486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A5FBE1E9-0A2F-414B-B6C1-DF5162E41B73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</a:t>
            </a:r>
            <a:r>
              <a:rPr lang="en-US" altLang="zh-CN" b="1" dirty="0"/>
              <a:t>2</a:t>
            </a:r>
            <a:endParaRPr lang="zh-CN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1F12596-2D87-4C5B-A6A7-6661103402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133" y="1265167"/>
            <a:ext cx="4780952" cy="396190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DE1F70D-C66C-4D49-83E0-FFF9C8C05F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24295" y="1265167"/>
            <a:ext cx="5295238" cy="402857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57679B1C-B509-4DA3-B290-AEDB9B1F5EDE}"/>
              </a:ext>
            </a:extLst>
          </p:cNvPr>
          <p:cNvSpPr txBox="1"/>
          <p:nvPr/>
        </p:nvSpPr>
        <p:spPr>
          <a:xfrm>
            <a:off x="249106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EF41544-7C1E-4377-92E6-F82256A8865F}"/>
              </a:ext>
            </a:extLst>
          </p:cNvPr>
          <p:cNvSpPr txBox="1"/>
          <p:nvPr/>
        </p:nvSpPr>
        <p:spPr>
          <a:xfrm>
            <a:off x="6368552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489156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A5FBE1E9-0A2F-414B-B6C1-DF5162E41B73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</a:t>
            </a:r>
            <a:r>
              <a:rPr lang="en-US" altLang="zh-CN" b="1" dirty="0"/>
              <a:t>2</a:t>
            </a:r>
            <a:endParaRPr lang="zh-CN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F68A231-B30E-4292-9CFF-65B4F891DA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707" y="1194130"/>
            <a:ext cx="4676190" cy="396190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00CDF0F-B233-4CD4-A532-D1F448C5ED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42834" y="1194131"/>
            <a:ext cx="5085714" cy="396190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85CD846-F284-4995-9DA2-0D4D8D9ADFE3}"/>
              </a:ext>
            </a:extLst>
          </p:cNvPr>
          <p:cNvSpPr txBox="1"/>
          <p:nvPr/>
        </p:nvSpPr>
        <p:spPr>
          <a:xfrm>
            <a:off x="496909" y="751954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748863B-4282-4221-832A-5348BEF70DDB}"/>
              </a:ext>
            </a:extLst>
          </p:cNvPr>
          <p:cNvSpPr txBox="1"/>
          <p:nvPr/>
        </p:nvSpPr>
        <p:spPr>
          <a:xfrm>
            <a:off x="6386394" y="751854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4C4CA4AB-7709-4634-A6CA-0F7B41CAD25D}"/>
              </a:ext>
            </a:extLst>
          </p:cNvPr>
          <p:cNvSpPr/>
          <p:nvPr/>
        </p:nvSpPr>
        <p:spPr>
          <a:xfrm>
            <a:off x="663452" y="5301724"/>
            <a:ext cx="1078054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The TMB and TNB comparison between different Sex and Age groups.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B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MB(A)/TNB(B) comparison between younger and older patients in this study. 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-D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MB(C)/TNB(D) comparison between Male and female patients in this study. </a:t>
            </a:r>
          </a:p>
        </p:txBody>
      </p:sp>
    </p:spTree>
    <p:extLst>
      <p:ext uri="{BB962C8B-B14F-4D97-AF65-F5344CB8AC3E}">
        <p14:creationId xmlns:p14="http://schemas.microsoft.com/office/powerpoint/2010/main" val="202804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81A66533-FB08-463B-91CC-878215305937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</a:t>
            </a:r>
            <a:r>
              <a:rPr lang="en-US" altLang="zh-CN" b="1" dirty="0"/>
              <a:t>3</a:t>
            </a:r>
            <a:endParaRPr lang="zh-CN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D7C600D8-DFB5-4CAA-A4ED-77F62BD8EA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552" y="1133948"/>
            <a:ext cx="4523809" cy="497142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C4300CF7-927D-4575-988E-CF92E64E4C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55471" y="1133948"/>
            <a:ext cx="6108346" cy="497142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29C5FE2-4089-466F-B749-7CBBC7C7B3D0}"/>
              </a:ext>
            </a:extLst>
          </p:cNvPr>
          <p:cNvSpPr txBox="1"/>
          <p:nvPr/>
        </p:nvSpPr>
        <p:spPr>
          <a:xfrm>
            <a:off x="249106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3829CD6-0D4B-4B77-B7CE-1349CAE0A145}"/>
              </a:ext>
            </a:extLst>
          </p:cNvPr>
          <p:cNvSpPr txBox="1"/>
          <p:nvPr/>
        </p:nvSpPr>
        <p:spPr>
          <a:xfrm>
            <a:off x="5855471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843553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96E4ECC-0C56-4973-BB1A-20B85FE24B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55481" y="1207629"/>
            <a:ext cx="3136519" cy="313651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9232AFB-C740-4389-9A1E-BDE57651013D}"/>
              </a:ext>
            </a:extLst>
          </p:cNvPr>
          <p:cNvSpPr txBox="1"/>
          <p:nvPr/>
        </p:nvSpPr>
        <p:spPr>
          <a:xfrm>
            <a:off x="9055481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11105B3-9F03-4D57-85C0-15FA2F9B7188}"/>
              </a:ext>
            </a:extLst>
          </p:cNvPr>
          <p:cNvSpPr txBox="1"/>
          <p:nvPr/>
        </p:nvSpPr>
        <p:spPr>
          <a:xfrm>
            <a:off x="249106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E4AB7826-7FEB-4AC0-94F9-DF9BC0363198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</a:t>
            </a:r>
            <a:r>
              <a:rPr lang="en-US" altLang="zh-CN" b="1" dirty="0"/>
              <a:t>3</a:t>
            </a:r>
            <a:endParaRPr lang="zh-CN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4942DCD3-933D-4CBA-99E1-CF6930E6E7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9106" y="1141843"/>
            <a:ext cx="8735594" cy="455557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AA36F5A-E0A6-497E-974C-7F6E68A99138}"/>
              </a:ext>
            </a:extLst>
          </p:cNvPr>
          <p:cNvSpPr txBox="1"/>
          <p:nvPr/>
        </p:nvSpPr>
        <p:spPr>
          <a:xfrm>
            <a:off x="1498096" y="5716157"/>
            <a:ext cx="10999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intestinal</a:t>
            </a:r>
            <a:endParaRPr lang="zh-CN" altLang="en-US" sz="16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CEC27C5-3F91-4634-A3AC-857463C6E08D}"/>
              </a:ext>
            </a:extLst>
          </p:cNvPr>
          <p:cNvSpPr txBox="1"/>
          <p:nvPr/>
        </p:nvSpPr>
        <p:spPr>
          <a:xfrm>
            <a:off x="4996039" y="5716157"/>
            <a:ext cx="10999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diffuse</a:t>
            </a:r>
            <a:endParaRPr lang="zh-CN" altLang="en-US" sz="16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0F7EFA9-51B6-4B4E-99F4-B242B4A05537}"/>
              </a:ext>
            </a:extLst>
          </p:cNvPr>
          <p:cNvSpPr txBox="1"/>
          <p:nvPr/>
        </p:nvSpPr>
        <p:spPr>
          <a:xfrm>
            <a:off x="7827887" y="5716157"/>
            <a:ext cx="10999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/>
              <a:t>mixed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1988843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E04E7569-CA44-4E00-89CD-494E6F45A87F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</a:t>
            </a:r>
            <a:r>
              <a:rPr lang="en-US" altLang="zh-CN" b="1" dirty="0"/>
              <a:t>3</a:t>
            </a:r>
            <a:endParaRPr lang="zh-CN" altLang="en-US" b="1" dirty="0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1EBB67E9-AB57-4BBA-BA6D-F9D6A0F5FF36}"/>
              </a:ext>
            </a:extLst>
          </p:cNvPr>
          <p:cNvSpPr/>
          <p:nvPr/>
        </p:nvSpPr>
        <p:spPr>
          <a:xfrm>
            <a:off x="593188" y="1499938"/>
            <a:ext cx="10780542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omatic CNVs in all tumors and sub-type tumors.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NV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trum of 74 samples. 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hromosomal locations of peaks of significantly recurring focal amplifications (red) and deletions (blue) are plotted. if false discovery rates &lt;0.25. Peaks are annotated with candidate driver oncogenes, tumor suppressors, or by cytoband. The number of genes within each peak is shown next to driver genes or cytobands. 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omatic CNVs in different subtype of GCs identified by GISTIC2.</a:t>
            </a:r>
          </a:p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overlap of cancer genes that amplified or deleted in three studies.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23772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内容占位符 6">
            <a:extLst>
              <a:ext uri="{FF2B5EF4-FFF2-40B4-BE49-F238E27FC236}">
                <a16:creationId xmlns:a16="http://schemas.microsoft.com/office/drawing/2014/main" id="{492B4BEF-0694-4FFA-A269-4CB905CDE9A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413" y="1369566"/>
            <a:ext cx="4368391" cy="4028628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0F1650AD-BEF1-4059-9BA6-389007EFB2EC}"/>
              </a:ext>
            </a:extLst>
          </p:cNvPr>
          <p:cNvSpPr/>
          <p:nvPr/>
        </p:nvSpPr>
        <p:spPr>
          <a:xfrm>
            <a:off x="205812" y="135375"/>
            <a:ext cx="2816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/>
              <a:t>Supplementary Figure S</a:t>
            </a:r>
            <a:r>
              <a:rPr lang="en-US" altLang="zh-CN" b="1" dirty="0"/>
              <a:t>4</a:t>
            </a:r>
            <a:endParaRPr lang="zh-CN" altLang="en-US" b="1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F2534F4D-348B-471D-9008-F3063C96C6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530719"/>
            <a:ext cx="4229686" cy="3867475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B6C7A1A-6416-405A-B7E2-01AAC1B87FE5}"/>
              </a:ext>
            </a:extLst>
          </p:cNvPr>
          <p:cNvSpPr txBox="1"/>
          <p:nvPr/>
        </p:nvSpPr>
        <p:spPr>
          <a:xfrm>
            <a:off x="249106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30774B3-D4FE-4B95-81BB-0B5C9B33C2CB}"/>
              </a:ext>
            </a:extLst>
          </p:cNvPr>
          <p:cNvSpPr txBox="1"/>
          <p:nvPr/>
        </p:nvSpPr>
        <p:spPr>
          <a:xfrm>
            <a:off x="6368552" y="679112"/>
            <a:ext cx="828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776D373C-5C01-42BF-B4F8-47191A1FC2F7}"/>
              </a:ext>
            </a:extLst>
          </p:cNvPr>
          <p:cNvSpPr/>
          <p:nvPr/>
        </p:nvSpPr>
        <p:spPr>
          <a:xfrm>
            <a:off x="694304" y="5719316"/>
            <a:ext cx="104007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ic alterations and their prognostic significance associated with PM. (A-B)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aplan-Meier plots for DFS in 1p36.21 and Xq26.3 for wildtype and mutated patients. 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4542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5</TotalTime>
  <Words>579</Words>
  <Application>Microsoft Office PowerPoint</Application>
  <PresentationFormat>宽屏</PresentationFormat>
  <Paragraphs>44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7" baseType="lpstr">
      <vt:lpstr>TimesNewRomanPS-BoldMT</vt:lpstr>
      <vt:lpstr>TimesNewRomanPSMT</vt:lpstr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超2(Chao Chen)</dc:creator>
  <cp:lastModifiedBy>chenchao2@genomics.cn</cp:lastModifiedBy>
  <cp:revision>60</cp:revision>
  <dcterms:created xsi:type="dcterms:W3CDTF">2019-06-08T13:50:54Z</dcterms:created>
  <dcterms:modified xsi:type="dcterms:W3CDTF">2019-09-11T05:26:37Z</dcterms:modified>
</cp:coreProperties>
</file>